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vml" ContentType="application/vnd.openxmlformats-officedocument.vmlDrawi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9" d="100"/>
          <a:sy n="89" d="100"/>
        </p:scale>
        <p:origin x="-136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037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32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226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812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3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634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862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507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784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554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006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39E6F-4E26-B444-9278-B1C418FF8A1C}" type="datetimeFigureOut">
              <a:rPr lang="en-US" smtClean="0"/>
              <a:t>30/0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C0359-FCFA-A54C-96AA-2ED5CD4197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539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1.emf"/><Relationship Id="rId5" Type="http://schemas.openxmlformats.org/officeDocument/2006/relationships/oleObject" Target="../embeddings/oleObject2.bin"/><Relationship Id="rId6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xmlns="" id="{FB0E3DDB-8D17-45B4-8603-BDE18476783F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541028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900" b="1" dirty="0" smtClean="0"/>
              <a:t>Supplementary Figure 1.</a:t>
            </a:r>
          </a:p>
          <a:p>
            <a:r>
              <a:rPr lang="en-GB" sz="1900" b="1" dirty="0" smtClean="0"/>
              <a:t>DMSO vs. single-treatments of PPL-008, n=3</a:t>
            </a:r>
            <a:r>
              <a:rPr lang="en-GB" sz="3600" b="1" dirty="0" smtClean="0"/>
              <a:t/>
            </a:r>
            <a:br>
              <a:rPr lang="en-GB" sz="3600" b="1" dirty="0" smtClean="0"/>
            </a:br>
            <a:r>
              <a:rPr lang="en-GB" sz="1200" b="1" dirty="0" err="1" smtClean="0"/>
              <a:t>xCELLigence</a:t>
            </a:r>
            <a:r>
              <a:rPr lang="en-GB" sz="1200" b="1" dirty="0" smtClean="0"/>
              <a:t> cell proliferation assay</a:t>
            </a:r>
            <a:br>
              <a:rPr lang="en-GB" sz="1200" b="1" dirty="0" smtClean="0"/>
            </a:br>
            <a:r>
              <a:rPr lang="en-GB" sz="1200" b="1" dirty="0" smtClean="0"/>
              <a:t>A375 (BRAF V600E) malignant melanoma cell line</a:t>
            </a:r>
            <a:endParaRPr lang="en-GB" sz="1200" b="1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A58D5ED4-B242-4F93-AC89-683B2BDE15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7389490"/>
              </p:ext>
            </p:extLst>
          </p:nvPr>
        </p:nvGraphicFramePr>
        <p:xfrm>
          <a:off x="4011932" y="2074150"/>
          <a:ext cx="2638025" cy="20210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Prism Project" r:id="rId3" imgW="5328000" imgH="3816000" progId="Prism5.Document">
                  <p:embed/>
                </p:oleObj>
              </mc:Choice>
              <mc:Fallback>
                <p:oleObj name="Prism Project" r:id="rId3" imgW="5328000" imgH="38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11932" y="2074150"/>
                        <a:ext cx="2638025" cy="20210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xmlns="" id="{386AFEAB-8CD6-45A0-A717-809443A152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9418391"/>
              </p:ext>
            </p:extLst>
          </p:nvPr>
        </p:nvGraphicFramePr>
        <p:xfrm>
          <a:off x="744021" y="1972974"/>
          <a:ext cx="2970000" cy="2203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Project" r:id="rId5" imgW="3528000" imgH="2520000" progId="Prism5.Document">
                  <p:embed/>
                </p:oleObj>
              </mc:Choice>
              <mc:Fallback>
                <p:oleObj name="Prism Project" r:id="rId5" imgW="3528000" imgH="252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44021" y="1972974"/>
                        <a:ext cx="2970000" cy="2203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C69311D-B219-4EC2-B2BB-ADF3A5CA20B8}"/>
              </a:ext>
            </a:extLst>
          </p:cNvPr>
          <p:cNvSpPr txBox="1"/>
          <p:nvPr/>
        </p:nvSpPr>
        <p:spPr>
          <a:xfrm>
            <a:off x="715446" y="179715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C5B8E928-C6E4-4F60-A5E3-FA0015F479D6}"/>
              </a:ext>
            </a:extLst>
          </p:cNvPr>
          <p:cNvSpPr txBox="1"/>
          <p:nvPr/>
        </p:nvSpPr>
        <p:spPr>
          <a:xfrm>
            <a:off x="3756097" y="1834474"/>
            <a:ext cx="268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B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900174E-50A5-4E80-BFE0-086F9E884386}"/>
              </a:ext>
            </a:extLst>
          </p:cNvPr>
          <p:cNvSpPr txBox="1"/>
          <p:nvPr/>
        </p:nvSpPr>
        <p:spPr>
          <a:xfrm>
            <a:off x="3238066" y="307031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*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1961A78-278E-4C7F-8EAF-986AD8CC1215}"/>
              </a:ext>
            </a:extLst>
          </p:cNvPr>
          <p:cNvSpPr txBox="1"/>
          <p:nvPr/>
        </p:nvSpPr>
        <p:spPr>
          <a:xfrm>
            <a:off x="2611293" y="283948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**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xmlns="" id="{2F6E7F5A-BB18-4653-9A9B-FE62D8A0CD36}"/>
              </a:ext>
            </a:extLst>
          </p:cNvPr>
          <p:cNvCxnSpPr/>
          <p:nvPr/>
        </p:nvCxnSpPr>
        <p:spPr>
          <a:xfrm>
            <a:off x="1782246" y="2378155"/>
            <a:ext cx="1696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6AEBBBE6-C80C-4798-B36B-C90E8CBF9158}"/>
              </a:ext>
            </a:extLst>
          </p:cNvPr>
          <p:cNvSpPr txBox="1"/>
          <p:nvPr/>
        </p:nvSpPr>
        <p:spPr>
          <a:xfrm>
            <a:off x="2307193" y="2166895"/>
            <a:ext cx="6479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vs. 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11A01D8-1412-4076-AB4F-9A27ABFEC8A3}"/>
              </a:ext>
            </a:extLst>
          </p:cNvPr>
          <p:cNvSpPr txBox="1"/>
          <p:nvPr/>
        </p:nvSpPr>
        <p:spPr>
          <a:xfrm>
            <a:off x="2939950" y="2734105"/>
            <a:ext cx="3145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N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1694408-68F0-4AF8-96D8-3F6469224A34}"/>
              </a:ext>
            </a:extLst>
          </p:cNvPr>
          <p:cNvSpPr txBox="1"/>
          <p:nvPr/>
        </p:nvSpPr>
        <p:spPr>
          <a:xfrm>
            <a:off x="1950607" y="2618689"/>
            <a:ext cx="3145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N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AF5D842-32A9-4785-86A5-9C5DF5C72855}"/>
              </a:ext>
            </a:extLst>
          </p:cNvPr>
          <p:cNvSpPr txBox="1"/>
          <p:nvPr/>
        </p:nvSpPr>
        <p:spPr>
          <a:xfrm>
            <a:off x="1616839" y="2653521"/>
            <a:ext cx="3145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NS</a:t>
            </a:r>
          </a:p>
        </p:txBody>
      </p:sp>
      <p:sp>
        <p:nvSpPr>
          <p:cNvPr id="17" name="Rectangle 16"/>
          <p:cNvSpPr/>
          <p:nvPr/>
        </p:nvSpPr>
        <p:spPr>
          <a:xfrm>
            <a:off x="263733" y="4176486"/>
            <a:ext cx="642993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 smtClean="0"/>
              <a:t>Single-treatment of 10µM PPL-008C and PPL-008CSS significantly attenuated A375 cell (V700E malignant melanoma cell line) growth although </a:t>
            </a:r>
            <a:r>
              <a:rPr lang="en-GB" sz="1200" dirty="0" err="1" smtClean="0"/>
              <a:t>pERK</a:t>
            </a:r>
            <a:r>
              <a:rPr lang="en-GB" sz="1200" dirty="0" smtClean="0"/>
              <a:t> levels are unaffected by these treatments (see Figure 1.). (MEAN ± STDEV, ** P &lt; 0.01, *** P &lt; 0.001, n = 3)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4013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2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Bailley</dc:creator>
  <cp:lastModifiedBy>George Bailley</cp:lastModifiedBy>
  <cp:revision>1</cp:revision>
  <dcterms:created xsi:type="dcterms:W3CDTF">2019-01-30T11:45:45Z</dcterms:created>
  <dcterms:modified xsi:type="dcterms:W3CDTF">2019-01-30T11:53:49Z</dcterms:modified>
</cp:coreProperties>
</file>